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67F1F5-5D05-464B-BFCF-05B751382DD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A7271A-5CF3-4C10-A8B8-C59ED994E06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66AA7E-3E94-401B-903F-DD26079266B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D48E7D-63C6-48BC-9CDF-D8012B48ED5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ED52CD-2A09-43B4-A857-F18CE28E00F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DD4336-DE35-4184-BF44-29120774B67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CFB81F-25A9-4B47-B431-24FC585BB4C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4988C1-FE34-41A7-82EA-4EDCA0C9531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EFC31E-089A-4D44-932D-941F0D1CE3A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744152-8D41-4C03-929D-B1E139CE1F3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D530B8-BC42-4762-8119-3675B92D0D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5E4A88-0EBE-4A38-A46B-39E9F0A7C9E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85C4CFD-80ED-4C92-B87E-A03F141E7F33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3.png"/><Relationship Id="rId3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image" Target="../media/image5.png"/><Relationship Id="rId3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image" Target="../media/image7.png"/><Relationship Id="rId3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image" Target="../media/image9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738440" y="1030320"/>
          <a:ext cx="6769080" cy="3657600"/>
        </p:xfrm>
        <a:graphic>
          <a:graphicData uri="http://schemas.openxmlformats.org/drawingml/2006/table">
            <a:tbl>
              <a:tblPr/>
              <a:tblGrid>
                <a:gridCol w="2255760"/>
                <a:gridCol w="2257200"/>
                <a:gridCol w="2256120"/>
              </a:tblGrid>
              <a:tr h="731880">
                <a:tc>
                  <a:txBody>
                    <a:bodyPr lIns="68400" rIns="6840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　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0" marR="684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LFD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(% of energy)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0" marR="684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HFD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(% of energy)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0" marR="684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65040">
                <a:tc>
                  <a:txBody>
                    <a:bodyPr lIns="68400" rIns="6840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  </a:t>
                      </a: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Lard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0" marR="684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-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0" marR="684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  </a:t>
                      </a: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48.87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0" marR="684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366840">
                <a:tc>
                  <a:txBody>
                    <a:bodyPr lIns="68400" rIns="6840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  </a:t>
                      </a: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Corn oil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-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  </a:t>
                      </a: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11.00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65040">
                <a:tc>
                  <a:txBody>
                    <a:bodyPr lIns="68400" rIns="6840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  </a:t>
                      </a: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Safflower oil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    </a:t>
                      </a: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9.46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-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65040">
                <a:tc>
                  <a:txBody>
                    <a:bodyPr lIns="68400" rIns="6840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  </a:t>
                      </a: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Casein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  </a:t>
                      </a: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24.92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  </a:t>
                      </a: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20.53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66840">
                <a:tc>
                  <a:txBody>
                    <a:bodyPr lIns="68400" rIns="6840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  </a:t>
                      </a: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DL-Methionine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    </a:t>
                      </a: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0.37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    </a:t>
                      </a: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0.15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65040">
                <a:tc>
                  <a:txBody>
                    <a:bodyPr lIns="68400" rIns="6840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  </a:t>
                      </a: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Dextrin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  </a:t>
                      </a: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47.32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  </a:t>
                      </a: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14.57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66840">
                <a:tc>
                  <a:txBody>
                    <a:bodyPr lIns="68400" rIns="6840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  </a:t>
                      </a: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Sucrose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  </a:t>
                      </a: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17.92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    </a:t>
                      </a: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4.89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65040">
                <a:tc>
                  <a:txBody>
                    <a:bodyPr lIns="68400" rIns="6840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  </a:t>
                      </a: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Total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  </a:t>
                      </a: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99.99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宋体"/>
                        </a:rPr>
                        <a:t>100.01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テキスト ボックス 4"/>
          <p:cNvSpPr/>
          <p:nvPr/>
        </p:nvSpPr>
        <p:spPr>
          <a:xfrm>
            <a:off x="220680" y="149400"/>
            <a:ext cx="38559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Table S1.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テキスト ボックス 3"/>
          <p:cNvSpPr/>
          <p:nvPr/>
        </p:nvSpPr>
        <p:spPr>
          <a:xfrm>
            <a:off x="220680" y="149400"/>
            <a:ext cx="38559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Table S2.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44" name=""/>
          <p:cNvGraphicFramePr/>
          <p:nvPr/>
        </p:nvGraphicFramePr>
        <p:xfrm>
          <a:off x="905040" y="919080"/>
          <a:ext cx="8967600" cy="1470240"/>
        </p:xfrm>
        <a:graphic>
          <a:graphicData uri="http://schemas.openxmlformats.org/drawingml/2006/table">
            <a:tbl>
              <a:tblPr/>
              <a:tblGrid>
                <a:gridCol w="3238200"/>
                <a:gridCol w="1909800"/>
                <a:gridCol w="1909800"/>
                <a:gridCol w="1909800"/>
              </a:tblGrid>
              <a:tr h="49068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FD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FD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</a:t>
                      </a: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value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8888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ood intake (g)/day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0 ± 0.2  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4 ± 0.3  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477 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9068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otal energy (Kcal/day)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.4 ± 0.4  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.3 ± 0.5  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34 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テキスト ボックス 3"/>
          <p:cNvSpPr/>
          <p:nvPr/>
        </p:nvSpPr>
        <p:spPr>
          <a:xfrm>
            <a:off x="220680" y="149400"/>
            <a:ext cx="38559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S1.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6" name="図 1" descr=""/>
          <p:cNvPicPr/>
          <p:nvPr/>
        </p:nvPicPr>
        <p:blipFill>
          <a:blip r:embed="rId1"/>
          <a:stretch/>
        </p:blipFill>
        <p:spPr>
          <a:xfrm>
            <a:off x="2147760" y="1049400"/>
            <a:ext cx="5018040" cy="4319640"/>
          </a:xfrm>
          <a:prstGeom prst="rect">
            <a:avLst/>
          </a:prstGeom>
          <a:ln w="0">
            <a:noFill/>
          </a:ln>
        </p:spPr>
      </p:pic>
      <p:sp>
        <p:nvSpPr>
          <p:cNvPr id="47" name="テキスト ボックス 1"/>
          <p:cNvSpPr/>
          <p:nvPr/>
        </p:nvSpPr>
        <p:spPr>
          <a:xfrm>
            <a:off x="6528240" y="2019240"/>
            <a:ext cx="1291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: </a:t>
            </a:r>
            <a:r>
              <a:rPr b="0" i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= 0.025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図 15" descr=""/>
          <p:cNvPicPr/>
          <p:nvPr/>
        </p:nvPicPr>
        <p:blipFill>
          <a:blip r:embed="rId1"/>
          <a:stretch/>
        </p:blipFill>
        <p:spPr>
          <a:xfrm>
            <a:off x="682560" y="987480"/>
            <a:ext cx="5040360" cy="5172120"/>
          </a:xfrm>
          <a:prstGeom prst="rect">
            <a:avLst/>
          </a:prstGeom>
          <a:ln w="0">
            <a:noFill/>
          </a:ln>
        </p:spPr>
      </p:pic>
      <p:sp>
        <p:nvSpPr>
          <p:cNvPr id="49" name="テキスト ボックス 3"/>
          <p:cNvSpPr/>
          <p:nvPr/>
        </p:nvSpPr>
        <p:spPr>
          <a:xfrm>
            <a:off x="220680" y="149400"/>
            <a:ext cx="38559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S2.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テキスト ボックス 6"/>
          <p:cNvSpPr/>
          <p:nvPr/>
        </p:nvSpPr>
        <p:spPr>
          <a:xfrm>
            <a:off x="682560" y="757080"/>
            <a:ext cx="4953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テキスト ボックス 6"/>
          <p:cNvSpPr/>
          <p:nvPr/>
        </p:nvSpPr>
        <p:spPr>
          <a:xfrm>
            <a:off x="6137280" y="757080"/>
            <a:ext cx="4953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2" name="図 1" descr=""/>
          <p:cNvPicPr/>
          <p:nvPr/>
        </p:nvPicPr>
        <p:blipFill>
          <a:blip r:embed="rId2"/>
          <a:stretch/>
        </p:blipFill>
        <p:spPr>
          <a:xfrm>
            <a:off x="6384960" y="1468440"/>
            <a:ext cx="4319640" cy="3708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テキスト ボックス 18"/>
          <p:cNvSpPr/>
          <p:nvPr/>
        </p:nvSpPr>
        <p:spPr>
          <a:xfrm>
            <a:off x="220680" y="123840"/>
            <a:ext cx="38559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</a:t>
            </a:r>
            <a:r>
              <a:rPr b="0" lang="en-US" sz="24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Figure S3</a:t>
            </a: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テキスト ボックス 6"/>
          <p:cNvSpPr/>
          <p:nvPr/>
        </p:nvSpPr>
        <p:spPr>
          <a:xfrm>
            <a:off x="682560" y="757080"/>
            <a:ext cx="4953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テキスト ボックス 6"/>
          <p:cNvSpPr/>
          <p:nvPr/>
        </p:nvSpPr>
        <p:spPr>
          <a:xfrm>
            <a:off x="682560" y="3735360"/>
            <a:ext cx="4953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6" name="図 1" descr=""/>
          <p:cNvPicPr/>
          <p:nvPr/>
        </p:nvPicPr>
        <p:blipFill>
          <a:blip r:embed="rId1"/>
          <a:stretch/>
        </p:blipFill>
        <p:spPr>
          <a:xfrm>
            <a:off x="1317600" y="903240"/>
            <a:ext cx="5759640" cy="2514600"/>
          </a:xfrm>
          <a:prstGeom prst="rect">
            <a:avLst/>
          </a:prstGeom>
          <a:ln w="0">
            <a:noFill/>
          </a:ln>
        </p:spPr>
      </p:pic>
      <p:pic>
        <p:nvPicPr>
          <p:cNvPr id="57" name="図 7" descr=""/>
          <p:cNvPicPr/>
          <p:nvPr/>
        </p:nvPicPr>
        <p:blipFill>
          <a:blip r:embed="rId2"/>
          <a:stretch/>
        </p:blipFill>
        <p:spPr>
          <a:xfrm>
            <a:off x="1909800" y="3735360"/>
            <a:ext cx="3959280" cy="2957400"/>
          </a:xfrm>
          <a:prstGeom prst="rect">
            <a:avLst/>
          </a:prstGeom>
          <a:ln w="0">
            <a:noFill/>
          </a:ln>
        </p:spPr>
      </p:pic>
      <p:sp>
        <p:nvSpPr>
          <p:cNvPr id="58" name="正方形/長方形 2"/>
          <p:cNvSpPr/>
          <p:nvPr/>
        </p:nvSpPr>
        <p:spPr>
          <a:xfrm>
            <a:off x="5782320" y="4844880"/>
            <a:ext cx="1194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ＭＳ ゴシック"/>
              </a:rPr>
              <a:t>**</a:t>
            </a:r>
            <a:r>
              <a:rPr b="0" i="1" lang="en-GB" sz="1800" spc="-1" strike="noStrike">
                <a:solidFill>
                  <a:srgbClr val="000000"/>
                </a:solidFill>
                <a:latin typeface="Times New Roman"/>
                <a:ea typeface="ＭＳ ゴシック"/>
              </a:rPr>
              <a:t>p &lt; </a:t>
            </a: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ＭＳ ゴシック"/>
              </a:rPr>
              <a:t>0.0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9" name="図 4" descr=""/>
          <p:cNvPicPr/>
          <p:nvPr/>
        </p:nvPicPr>
        <p:blipFill>
          <a:blip r:embed="rId1"/>
          <a:stretch/>
        </p:blipFill>
        <p:spPr>
          <a:xfrm>
            <a:off x="6253200" y="1258920"/>
            <a:ext cx="4092480" cy="2519280"/>
          </a:xfrm>
          <a:prstGeom prst="rect">
            <a:avLst/>
          </a:prstGeom>
          <a:ln w="0">
            <a:noFill/>
          </a:ln>
        </p:spPr>
      </p:pic>
      <p:pic>
        <p:nvPicPr>
          <p:cNvPr id="60" name="図 1" descr=""/>
          <p:cNvPicPr/>
          <p:nvPr/>
        </p:nvPicPr>
        <p:blipFill>
          <a:blip r:embed="rId2"/>
          <a:stretch/>
        </p:blipFill>
        <p:spPr>
          <a:xfrm>
            <a:off x="930240" y="898560"/>
            <a:ext cx="4765680" cy="5759280"/>
          </a:xfrm>
          <a:prstGeom prst="rect">
            <a:avLst/>
          </a:prstGeom>
          <a:ln w="0">
            <a:noFill/>
          </a:ln>
        </p:spPr>
      </p:pic>
      <p:sp>
        <p:nvSpPr>
          <p:cNvPr id="61" name="テキスト ボックス 3"/>
          <p:cNvSpPr/>
          <p:nvPr/>
        </p:nvSpPr>
        <p:spPr>
          <a:xfrm>
            <a:off x="220680" y="123840"/>
            <a:ext cx="38559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</a:t>
            </a:r>
            <a:r>
              <a:rPr b="0" lang="en-US" sz="24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Figure S4</a:t>
            </a: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テキスト ボックス 6"/>
          <p:cNvSpPr/>
          <p:nvPr/>
        </p:nvSpPr>
        <p:spPr>
          <a:xfrm>
            <a:off x="682560" y="757080"/>
            <a:ext cx="4953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テキスト ボックス 6"/>
          <p:cNvSpPr/>
          <p:nvPr/>
        </p:nvSpPr>
        <p:spPr>
          <a:xfrm>
            <a:off x="6137280" y="757080"/>
            <a:ext cx="4953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4" name="図 3" descr=""/>
          <p:cNvPicPr/>
          <p:nvPr/>
        </p:nvPicPr>
        <p:blipFill>
          <a:blip r:embed="rId1"/>
          <a:stretch/>
        </p:blipFill>
        <p:spPr>
          <a:xfrm>
            <a:off x="930240" y="988920"/>
            <a:ext cx="4788000" cy="5759640"/>
          </a:xfrm>
          <a:prstGeom prst="rect">
            <a:avLst/>
          </a:prstGeom>
          <a:ln w="0">
            <a:noFill/>
          </a:ln>
        </p:spPr>
      </p:pic>
      <p:pic>
        <p:nvPicPr>
          <p:cNvPr id="65" name="図 4" descr=""/>
          <p:cNvPicPr/>
          <p:nvPr/>
        </p:nvPicPr>
        <p:blipFill>
          <a:blip r:embed="rId2"/>
          <a:stretch/>
        </p:blipFill>
        <p:spPr>
          <a:xfrm>
            <a:off x="6227640" y="1219320"/>
            <a:ext cx="4095720" cy="2519280"/>
          </a:xfrm>
          <a:prstGeom prst="rect">
            <a:avLst/>
          </a:prstGeom>
          <a:ln w="0">
            <a:noFill/>
          </a:ln>
        </p:spPr>
      </p:pic>
      <p:sp>
        <p:nvSpPr>
          <p:cNvPr id="66" name="テキスト ボックス 3"/>
          <p:cNvSpPr/>
          <p:nvPr/>
        </p:nvSpPr>
        <p:spPr>
          <a:xfrm>
            <a:off x="220680" y="123840"/>
            <a:ext cx="38559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</a:t>
            </a:r>
            <a:r>
              <a:rPr b="0" lang="en-US" sz="24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Figure S5.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テキスト ボックス 6"/>
          <p:cNvSpPr/>
          <p:nvPr/>
        </p:nvSpPr>
        <p:spPr>
          <a:xfrm>
            <a:off x="682560" y="757080"/>
            <a:ext cx="4953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テキスト ボックス 6"/>
          <p:cNvSpPr/>
          <p:nvPr/>
        </p:nvSpPr>
        <p:spPr>
          <a:xfrm>
            <a:off x="6137280" y="757080"/>
            <a:ext cx="4953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1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3-17T06:38:20Z</dcterms:created>
  <dc:creator>akira tomota</dc:creator>
  <dc:description/>
  <dc:language>en-US</dc:language>
  <cp:lastModifiedBy>huangmingguo</cp:lastModifiedBy>
  <dcterms:modified xsi:type="dcterms:W3CDTF">2015-11-23T06:55:36Z</dcterms:modified>
  <cp:revision>24</cp:revision>
  <dc:subject/>
  <dc:title>PowerPoint プレゼンテーション</dc:title>
</cp:coreProperties>
</file>